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92" autoAdjust="0"/>
  </p:normalViewPr>
  <p:slideViewPr>
    <p:cSldViewPr snapToGrid="0" showGuides="1">
      <p:cViewPr>
        <p:scale>
          <a:sx n="66" d="100"/>
          <a:sy n="66" d="100"/>
        </p:scale>
        <p:origin x="-3536" y="-1616"/>
      </p:cViewPr>
      <p:guideLst>
        <p:guide orient="horz" pos="345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A718F9-70E3-4249-AAB7-76D2D7D33334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F4B64E-ADA1-42CC-921D-01437FCFDAE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431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F4B64E-ADA1-42CC-921D-01437FCFDAE8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04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581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181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25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323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341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732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160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42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154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885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8EC4F-ED6D-4DBB-BF1B-BB7E7745BD0F}" type="datetimeFigureOut">
              <a:rPr lang="en-US" smtClean="0"/>
              <a:pPr/>
              <a:t>11/22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884A70-C8B8-44E1-9214-DF292996A6D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516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11" t="11755" r="34622" b="28022"/>
          <a:stretch>
            <a:fillRect/>
          </a:stretch>
        </p:blipFill>
        <p:spPr bwMode="auto">
          <a:xfrm>
            <a:off x="972152" y="1491657"/>
            <a:ext cx="2718306" cy="20212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TextBox 46"/>
          <p:cNvSpPr txBox="1"/>
          <p:nvPr/>
        </p:nvSpPr>
        <p:spPr>
          <a:xfrm>
            <a:off x="4343400" y="3604382"/>
            <a:ext cx="2743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omponent 1 (58.7%)</a:t>
            </a:r>
            <a:endParaRPr lang="en-US" sz="12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6644375" y="3608233"/>
            <a:ext cx="2743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omponent 3 (4.7%)</a:t>
            </a:r>
            <a:endParaRPr lang="en-US" sz="12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-190500" y="3601180"/>
            <a:ext cx="2743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omponent 1 (16.8%)</a:t>
            </a:r>
            <a:endParaRPr lang="en-US" sz="12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2091932" y="3598379"/>
            <a:ext cx="2743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/>
              <a:t>Component 3 (4.9%)</a:t>
            </a:r>
            <a:endParaRPr lang="en-US" sz="1200" b="1" dirty="0"/>
          </a:p>
        </p:txBody>
      </p:sp>
      <p:grpSp>
        <p:nvGrpSpPr>
          <p:cNvPr id="62" name="Group 61"/>
          <p:cNvGrpSpPr/>
          <p:nvPr/>
        </p:nvGrpSpPr>
        <p:grpSpPr>
          <a:xfrm>
            <a:off x="953882" y="1092730"/>
            <a:ext cx="2743200" cy="490498"/>
            <a:chOff x="4090782" y="303726"/>
            <a:chExt cx="2743200" cy="490498"/>
          </a:xfrm>
        </p:grpSpPr>
        <p:sp>
          <p:nvSpPr>
            <p:cNvPr id="52" name="TextBox 51"/>
            <p:cNvSpPr txBox="1"/>
            <p:nvPr/>
          </p:nvSpPr>
          <p:spPr>
            <a:xfrm>
              <a:off x="5307307" y="517225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Y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090782" y="303726"/>
              <a:ext cx="2743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omponent 2 (8.8%)</a:t>
              </a:r>
              <a:endParaRPr lang="en-US" sz="1200" b="1" dirty="0"/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824700" y="3389429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X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552925" y="3379804"/>
            <a:ext cx="381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Z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20500" y="9859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03" name="TextBox 102"/>
          <p:cNvSpPr txBox="1"/>
          <p:nvPr/>
        </p:nvSpPr>
        <p:spPr>
          <a:xfrm>
            <a:off x="4640076" y="98359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grpSp>
        <p:nvGrpSpPr>
          <p:cNvPr id="89" name="Group 88"/>
          <p:cNvGrpSpPr/>
          <p:nvPr/>
        </p:nvGrpSpPr>
        <p:grpSpPr>
          <a:xfrm>
            <a:off x="5310950" y="1101154"/>
            <a:ext cx="3118775" cy="2555649"/>
            <a:chOff x="5310950" y="312150"/>
            <a:chExt cx="3118775" cy="2555649"/>
          </a:xfrm>
        </p:grpSpPr>
        <p:sp>
          <p:nvSpPr>
            <p:cNvPr id="44" name="TextBox 43"/>
            <p:cNvSpPr txBox="1"/>
            <p:nvPr/>
          </p:nvSpPr>
          <p:spPr>
            <a:xfrm>
              <a:off x="6653223" y="510801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Y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048725" y="2590800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Z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432125" y="312150"/>
              <a:ext cx="2743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/>
                <a:t>Component 2 (8.4%)</a:t>
              </a:r>
              <a:endParaRPr lang="en-US" sz="1200" b="1" dirty="0"/>
            </a:p>
          </p:txBody>
        </p:sp>
        <p:pic>
          <p:nvPicPr>
            <p:cNvPr id="80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11" t="13454" r="37320" b="27166"/>
            <a:stretch>
              <a:fillRect/>
            </a:stretch>
          </p:blipFill>
          <p:spPr bwMode="auto">
            <a:xfrm>
              <a:off x="5534529" y="736130"/>
              <a:ext cx="2550695" cy="20936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1" name="Rectangle 80"/>
            <p:cNvSpPr/>
            <p:nvPr/>
          </p:nvSpPr>
          <p:spPr>
            <a:xfrm>
              <a:off x="5611529" y="2531463"/>
              <a:ext cx="490888" cy="22138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5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11" t="63996" r="56620" b="29408"/>
            <a:stretch>
              <a:fillRect/>
            </a:stretch>
          </p:blipFill>
          <p:spPr bwMode="auto">
            <a:xfrm>
              <a:off x="5484795" y="2425567"/>
              <a:ext cx="914403" cy="2887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5" name="TextBox 44"/>
            <p:cNvSpPr txBox="1"/>
            <p:nvPr/>
          </p:nvSpPr>
          <p:spPr>
            <a:xfrm>
              <a:off x="5310950" y="2590798"/>
              <a:ext cx="2525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X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481010" y="4326336"/>
            <a:ext cx="848982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Additional File 1.  </a:t>
            </a:r>
            <a:r>
              <a:rPr lang="en-US" b="1" dirty="0"/>
              <a:t>Unsupervised PCA of D0 (triangle) and M1 (circle) </a:t>
            </a:r>
            <a:r>
              <a:rPr lang="en-US" b="1" dirty="0" smtClean="0"/>
              <a:t>samples. </a:t>
            </a:r>
            <a:r>
              <a:rPr lang="en-US" dirty="0" smtClean="0"/>
              <a:t>The </a:t>
            </a:r>
            <a:r>
              <a:rPr lang="en-US" dirty="0"/>
              <a:t>PCAs were constructed based on MFs present in at least 70% and 50% of the samples for any given time point of </a:t>
            </a:r>
            <a:r>
              <a:rPr lang="en-US" dirty="0" smtClean="0"/>
              <a:t>Discovery Set</a:t>
            </a:r>
            <a:r>
              <a:rPr lang="en-US" dirty="0" smtClean="0"/>
              <a:t>-1  </a:t>
            </a:r>
            <a:r>
              <a:rPr lang="en-US" dirty="0"/>
              <a:t>(A) and </a:t>
            </a:r>
            <a:r>
              <a:rPr lang="en-US" dirty="0" smtClean="0"/>
              <a:t>Discovery Set</a:t>
            </a:r>
            <a:r>
              <a:rPr lang="en-US" dirty="0" smtClean="0"/>
              <a:t>-2 </a:t>
            </a:r>
            <a:r>
              <a:rPr lang="en-US" dirty="0"/>
              <a:t>(B), respectively, and that differed in abundance between time points by at least 2 fold with a p&lt;0.05. </a:t>
            </a:r>
          </a:p>
        </p:txBody>
      </p:sp>
    </p:spTree>
    <p:extLst>
      <p:ext uri="{BB962C8B-B14F-4D97-AF65-F5344CB8AC3E}">
        <p14:creationId xmlns:p14="http://schemas.microsoft.com/office/powerpoint/2010/main" val="1945092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125</Words>
  <Application>Microsoft Macintosh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VMBS Computing Resources Grou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patra,Sebabrata</dc:creator>
  <cp:lastModifiedBy>John T Belisle</cp:lastModifiedBy>
  <cp:revision>18</cp:revision>
  <dcterms:created xsi:type="dcterms:W3CDTF">2012-11-12T01:43:53Z</dcterms:created>
  <dcterms:modified xsi:type="dcterms:W3CDTF">2013-11-22T17:51:24Z</dcterms:modified>
</cp:coreProperties>
</file>